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76" d="100"/>
          <a:sy n="76" d="100"/>
        </p:scale>
        <p:origin x="126" y="8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007B21-1076-4BBE-81D1-E2DBAE3233C9}" type="datetimeFigureOut">
              <a:rPr lang="ko-KR" altLang="en-US" smtClean="0"/>
              <a:t>2019-02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54CFC-482A-45F0-ACAA-8E1D3141CB9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532957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007B21-1076-4BBE-81D1-E2DBAE3233C9}" type="datetimeFigureOut">
              <a:rPr lang="ko-KR" altLang="en-US" smtClean="0"/>
              <a:t>2019-02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54CFC-482A-45F0-ACAA-8E1D3141CB9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331879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007B21-1076-4BBE-81D1-E2DBAE3233C9}" type="datetimeFigureOut">
              <a:rPr lang="ko-KR" altLang="en-US" smtClean="0"/>
              <a:t>2019-02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54CFC-482A-45F0-ACAA-8E1D3141CB9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81906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007B21-1076-4BBE-81D1-E2DBAE3233C9}" type="datetimeFigureOut">
              <a:rPr lang="ko-KR" altLang="en-US" smtClean="0"/>
              <a:t>2019-02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54CFC-482A-45F0-ACAA-8E1D3141CB9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028055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007B21-1076-4BBE-81D1-E2DBAE3233C9}" type="datetimeFigureOut">
              <a:rPr lang="ko-KR" altLang="en-US" smtClean="0"/>
              <a:t>2019-02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54CFC-482A-45F0-ACAA-8E1D3141CB9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992960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007B21-1076-4BBE-81D1-E2DBAE3233C9}" type="datetimeFigureOut">
              <a:rPr lang="ko-KR" altLang="en-US" smtClean="0"/>
              <a:t>2019-02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54CFC-482A-45F0-ACAA-8E1D3141CB9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73317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007B21-1076-4BBE-81D1-E2DBAE3233C9}" type="datetimeFigureOut">
              <a:rPr lang="ko-KR" altLang="en-US" smtClean="0"/>
              <a:t>2019-02-14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54CFC-482A-45F0-ACAA-8E1D3141CB9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891205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007B21-1076-4BBE-81D1-E2DBAE3233C9}" type="datetimeFigureOut">
              <a:rPr lang="ko-KR" altLang="en-US" smtClean="0"/>
              <a:t>2019-02-14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54CFC-482A-45F0-ACAA-8E1D3141CB9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551075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007B21-1076-4BBE-81D1-E2DBAE3233C9}" type="datetimeFigureOut">
              <a:rPr lang="ko-KR" altLang="en-US" smtClean="0"/>
              <a:t>2019-02-14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54CFC-482A-45F0-ACAA-8E1D3141CB9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274399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007B21-1076-4BBE-81D1-E2DBAE3233C9}" type="datetimeFigureOut">
              <a:rPr lang="ko-KR" altLang="en-US" smtClean="0"/>
              <a:t>2019-02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54CFC-482A-45F0-ACAA-8E1D3141CB9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302063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007B21-1076-4BBE-81D1-E2DBAE3233C9}" type="datetimeFigureOut">
              <a:rPr lang="ko-KR" altLang="en-US" smtClean="0"/>
              <a:t>2019-02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54CFC-482A-45F0-ACAA-8E1D3141CB9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36736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007B21-1076-4BBE-81D1-E2DBAE3233C9}" type="datetimeFigureOut">
              <a:rPr lang="ko-KR" altLang="en-US" smtClean="0"/>
              <a:t>2019-02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154CFC-482A-45F0-ACAA-8E1D3141CB9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535494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그림 27"/>
          <p:cNvPicPr>
            <a:picLocks noChangeAspect="1"/>
          </p:cNvPicPr>
          <p:nvPr/>
        </p:nvPicPr>
        <p:blipFill rotWithShape="1">
          <a:blip r:embed="rId2"/>
          <a:srcRect l="6302" t="7483" r="24745" b="8503"/>
          <a:stretch/>
        </p:blipFill>
        <p:spPr>
          <a:xfrm>
            <a:off x="455096" y="754950"/>
            <a:ext cx="5577024" cy="5444788"/>
          </a:xfrm>
          <a:prstGeom prst="rect">
            <a:avLst/>
          </a:prstGeom>
        </p:spPr>
      </p:pic>
      <p:pic>
        <p:nvPicPr>
          <p:cNvPr id="25" name="그림 24"/>
          <p:cNvPicPr>
            <a:picLocks noChangeAspect="1"/>
          </p:cNvPicPr>
          <p:nvPr/>
        </p:nvPicPr>
        <p:blipFill rotWithShape="1">
          <a:blip r:embed="rId3"/>
          <a:srcRect l="6575" t="7143" r="25017" b="8843"/>
          <a:stretch/>
        </p:blipFill>
        <p:spPr>
          <a:xfrm>
            <a:off x="6505837" y="722292"/>
            <a:ext cx="5532944" cy="5444788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9447" y="2006064"/>
            <a:ext cx="461665" cy="275876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altLang="ko-KR" dirty="0" smtClean="0"/>
              <a:t>Progression free survival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2468329" y="6167080"/>
            <a:ext cx="1556657" cy="3806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Time (month)</a:t>
            </a:r>
            <a:endParaRPr lang="ko-KR" altLang="en-US" dirty="0"/>
          </a:p>
        </p:txBody>
      </p:sp>
      <p:cxnSp>
        <p:nvCxnSpPr>
          <p:cNvPr id="9" name="직선 연결선 8"/>
          <p:cNvCxnSpPr/>
          <p:nvPr/>
        </p:nvCxnSpPr>
        <p:spPr>
          <a:xfrm>
            <a:off x="4272639" y="1282700"/>
            <a:ext cx="279400" cy="0"/>
          </a:xfrm>
          <a:prstGeom prst="line">
            <a:avLst/>
          </a:prstGeom>
          <a:ln w="25400">
            <a:solidFill>
              <a:schemeClr val="accent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직선 연결선 10"/>
          <p:cNvCxnSpPr/>
          <p:nvPr/>
        </p:nvCxnSpPr>
        <p:spPr>
          <a:xfrm>
            <a:off x="4281710" y="1598389"/>
            <a:ext cx="279400" cy="0"/>
          </a:xfrm>
          <a:prstGeom prst="line">
            <a:avLst/>
          </a:prstGeom>
          <a:ln w="254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4654547" y="1061357"/>
            <a:ext cx="10604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No ATB</a:t>
            </a:r>
            <a:endParaRPr lang="ko-KR" alt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4663618" y="1413723"/>
            <a:ext cx="10441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ATB 30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4654547" y="2140468"/>
            <a:ext cx="10531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i="1" dirty="0"/>
              <a:t>p</a:t>
            </a:r>
            <a:r>
              <a:rPr lang="en-US" altLang="ko-KR" dirty="0" smtClean="0"/>
              <a:t>&lt;0.001</a:t>
            </a:r>
            <a:endParaRPr lang="ko-KR" alt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6099703" y="2470329"/>
            <a:ext cx="461665" cy="188682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altLang="ko-KR" dirty="0" smtClean="0"/>
              <a:t>Overall survival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8570689" y="6167080"/>
            <a:ext cx="1556657" cy="3806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Time (month)</a:t>
            </a:r>
            <a:endParaRPr lang="ko-KR" altLang="en-US" dirty="0"/>
          </a:p>
        </p:txBody>
      </p:sp>
      <p:cxnSp>
        <p:nvCxnSpPr>
          <p:cNvPr id="19" name="직선 연결선 18"/>
          <p:cNvCxnSpPr/>
          <p:nvPr/>
        </p:nvCxnSpPr>
        <p:spPr>
          <a:xfrm>
            <a:off x="10244368" y="1282700"/>
            <a:ext cx="279400" cy="0"/>
          </a:xfrm>
          <a:prstGeom prst="line">
            <a:avLst/>
          </a:prstGeom>
          <a:ln w="25400">
            <a:solidFill>
              <a:schemeClr val="accent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직선 연결선 19"/>
          <p:cNvCxnSpPr/>
          <p:nvPr/>
        </p:nvCxnSpPr>
        <p:spPr>
          <a:xfrm>
            <a:off x="10253439" y="1598389"/>
            <a:ext cx="279400" cy="0"/>
          </a:xfrm>
          <a:prstGeom prst="line">
            <a:avLst/>
          </a:prstGeom>
          <a:ln w="254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10626276" y="1061357"/>
            <a:ext cx="10604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No ATB</a:t>
            </a:r>
            <a:endParaRPr lang="ko-KR" altLang="en-US" dirty="0"/>
          </a:p>
        </p:txBody>
      </p:sp>
      <p:cxnSp>
        <p:nvCxnSpPr>
          <p:cNvPr id="26" name="직선 연결선 25"/>
          <p:cNvCxnSpPr/>
          <p:nvPr/>
        </p:nvCxnSpPr>
        <p:spPr>
          <a:xfrm>
            <a:off x="4270822" y="1930405"/>
            <a:ext cx="279400" cy="0"/>
          </a:xfrm>
          <a:prstGeom prst="line">
            <a:avLst/>
          </a:prstGeom>
          <a:ln w="254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4669059" y="1745739"/>
            <a:ext cx="10441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ATB 60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10644414" y="1413723"/>
            <a:ext cx="10441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ATB 30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10635343" y="2153168"/>
            <a:ext cx="10531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i="1" dirty="0"/>
              <a:t>p</a:t>
            </a:r>
            <a:r>
              <a:rPr lang="en-US" altLang="ko-KR" dirty="0" smtClean="0"/>
              <a:t>&lt;0.001</a:t>
            </a:r>
            <a:endParaRPr lang="ko-KR" altLang="en-US" dirty="0"/>
          </a:p>
        </p:txBody>
      </p:sp>
      <p:cxnSp>
        <p:nvCxnSpPr>
          <p:cNvPr id="30" name="직선 연결선 29"/>
          <p:cNvCxnSpPr/>
          <p:nvPr/>
        </p:nvCxnSpPr>
        <p:spPr>
          <a:xfrm>
            <a:off x="10251618" y="1930405"/>
            <a:ext cx="279400" cy="0"/>
          </a:xfrm>
          <a:prstGeom prst="line">
            <a:avLst/>
          </a:prstGeom>
          <a:ln w="254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10649855" y="1745739"/>
            <a:ext cx="10441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ATB 60</a:t>
            </a:r>
          </a:p>
        </p:txBody>
      </p:sp>
    </p:spTree>
    <p:extLst>
      <p:ext uri="{BB962C8B-B14F-4D97-AF65-F5344CB8AC3E}">
        <p14:creationId xmlns:p14="http://schemas.microsoft.com/office/powerpoint/2010/main" val="26939663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</TotalTime>
  <Words>27</Words>
  <Application>Microsoft Office PowerPoint</Application>
  <PresentationFormat>와이드스크린</PresentationFormat>
  <Paragraphs>12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cmc-ssm</dc:creator>
  <cp:lastModifiedBy>cmc-ssm</cp:lastModifiedBy>
  <cp:revision>4</cp:revision>
  <dcterms:created xsi:type="dcterms:W3CDTF">2019-02-11T01:27:50Z</dcterms:created>
  <dcterms:modified xsi:type="dcterms:W3CDTF">2019-02-14T04:41:06Z</dcterms:modified>
</cp:coreProperties>
</file>